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6"/>
  </p:notesMasterIdLst>
  <p:sldIdLst>
    <p:sldId id="266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96" autoAdjust="0"/>
    <p:restoredTop sz="95670" autoAdjust="0"/>
  </p:normalViewPr>
  <p:slideViewPr>
    <p:cSldViewPr snapToGrid="0">
      <p:cViewPr varScale="1">
        <p:scale>
          <a:sx n="119" d="100"/>
          <a:sy n="119" d="100"/>
        </p:scale>
        <p:origin x="2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A751A8-ECBB-4AFD-922D-D97D9235E996}" type="datetimeFigureOut">
              <a:rPr lang="en-US" smtClean="0"/>
              <a:t>8/2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36322F-50EC-4C75-9751-99655712D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452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2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63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45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27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09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090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272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454" algn="l" defTabSz="91436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494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485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149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74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24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76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640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477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041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51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454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41B07-2632-4B5D-8799-86BA8C1AA18D}" type="datetimeFigureOut">
              <a:rPr lang="en-US" smtClean="0"/>
              <a:t>8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D3338-CC6D-49C8-9B83-BC7DCFFFB5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741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772C2234-2797-6FF4-39C9-67729EFA14A5}"/>
              </a:ext>
            </a:extLst>
          </p:cNvPr>
          <p:cNvSpPr txBox="1"/>
          <p:nvPr/>
        </p:nvSpPr>
        <p:spPr>
          <a:xfrm>
            <a:off x="9946041" y="230693"/>
            <a:ext cx="1887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Helvetica" pitchFamily="2" charset="0"/>
              </a:rPr>
              <a:t>Su</a:t>
            </a:r>
            <a:r>
              <a:rPr lang="en-US" sz="1200" b="1" dirty="0">
                <a:latin typeface="Helvetica" pitchFamily="2" charset="0"/>
              </a:rPr>
              <a:t> et al., Suppl. Fig. 1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C027BD36-5AF3-0559-1D4D-3D17A26D78A3}"/>
              </a:ext>
            </a:extLst>
          </p:cNvPr>
          <p:cNvGrpSpPr/>
          <p:nvPr/>
        </p:nvGrpSpPr>
        <p:grpSpPr>
          <a:xfrm>
            <a:off x="2248350" y="406102"/>
            <a:ext cx="7218381" cy="2762179"/>
            <a:chOff x="2302138" y="685801"/>
            <a:chExt cx="7218381" cy="2762179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28A2CDD6-4BCB-A29B-18C5-38F80DCB6B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87893" y="944556"/>
              <a:ext cx="2346985" cy="23959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3DA48CF-932C-ABC9-6F81-169F61C837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73534" y="944556"/>
              <a:ext cx="2346985" cy="23959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2E3A3BDB-9843-5B4D-E80B-41D0BFB125A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76190" y="944556"/>
              <a:ext cx="2346985" cy="23959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7225D98-D6D4-A7CB-A7AF-32E5834505A1}"/>
                </a:ext>
              </a:extLst>
            </p:cNvPr>
            <p:cNvSpPr txBox="1"/>
            <p:nvPr/>
          </p:nvSpPr>
          <p:spPr>
            <a:xfrm>
              <a:off x="2370621" y="944556"/>
              <a:ext cx="1176420" cy="259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11.5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84B1EFA-3F93-FD04-1AD2-342C352174F3}"/>
                </a:ext>
              </a:extLst>
            </p:cNvPr>
            <p:cNvSpPr txBox="1"/>
            <p:nvPr/>
          </p:nvSpPr>
          <p:spPr>
            <a:xfrm>
              <a:off x="4768115" y="944556"/>
              <a:ext cx="1176420" cy="259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13.5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B317150-F3E4-BEFF-87B6-0B6A64110901}"/>
                </a:ext>
              </a:extLst>
            </p:cNvPr>
            <p:cNvSpPr txBox="1"/>
            <p:nvPr/>
          </p:nvSpPr>
          <p:spPr>
            <a:xfrm>
              <a:off x="7173533" y="941221"/>
              <a:ext cx="1176420" cy="259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14.5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71E82DB-9E58-A0D4-B962-A0577381DCE3}"/>
                </a:ext>
              </a:extLst>
            </p:cNvPr>
            <p:cNvSpPr txBox="1"/>
            <p:nvPr/>
          </p:nvSpPr>
          <p:spPr>
            <a:xfrm>
              <a:off x="2351189" y="3115846"/>
              <a:ext cx="10589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0 </a:t>
              </a:r>
              <a:r>
                <a:rPr lang="el-GR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3187C1F-2D32-BDD7-ED0E-7F0FA9199EAA}"/>
                </a:ext>
              </a:extLst>
            </p:cNvPr>
            <p:cNvSpPr txBox="1"/>
            <p:nvPr/>
          </p:nvSpPr>
          <p:spPr>
            <a:xfrm>
              <a:off x="4730831" y="3124913"/>
              <a:ext cx="9169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0 </a:t>
              </a:r>
              <a:r>
                <a:rPr lang="el-GR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98D9EF7-BADF-CD4C-0D5E-D6769E2E9729}"/>
                </a:ext>
              </a:extLst>
            </p:cNvPr>
            <p:cNvSpPr txBox="1"/>
            <p:nvPr/>
          </p:nvSpPr>
          <p:spPr>
            <a:xfrm>
              <a:off x="7141300" y="3140203"/>
              <a:ext cx="9161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0 </a:t>
              </a:r>
              <a:r>
                <a:rPr lang="el-GR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AB852D2-C416-CAF1-5418-63F7C34D5970}"/>
                </a:ext>
              </a:extLst>
            </p:cNvPr>
            <p:cNvSpPr txBox="1"/>
            <p:nvPr/>
          </p:nvSpPr>
          <p:spPr>
            <a:xfrm>
              <a:off x="3178792" y="1701821"/>
              <a:ext cx="358659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E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EA5B63C-B513-3934-AFD9-E1C0F89F8F20}"/>
                </a:ext>
              </a:extLst>
            </p:cNvPr>
            <p:cNvSpPr txBox="1"/>
            <p:nvPr/>
          </p:nvSpPr>
          <p:spPr>
            <a:xfrm>
              <a:off x="3490238" y="2343212"/>
              <a:ext cx="382464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2788D05E-E5F8-AF0A-B43E-F981C40705CB}"/>
                </a:ext>
              </a:extLst>
            </p:cNvPr>
            <p:cNvCxnSpPr>
              <a:cxnSpLocks/>
            </p:cNvCxnSpPr>
            <p:nvPr/>
          </p:nvCxnSpPr>
          <p:spPr>
            <a:xfrm>
              <a:off x="3451754" y="1983937"/>
              <a:ext cx="76967" cy="135999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323474F-0949-F258-AC3C-A5BDEF399B9B}"/>
                </a:ext>
              </a:extLst>
            </p:cNvPr>
            <p:cNvSpPr txBox="1"/>
            <p:nvPr/>
          </p:nvSpPr>
          <p:spPr>
            <a:xfrm>
              <a:off x="4227659" y="2978740"/>
              <a:ext cx="365273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d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EA92F72-FED1-9A5C-B8D3-70CBA52081EC}"/>
                </a:ext>
              </a:extLst>
            </p:cNvPr>
            <p:cNvSpPr txBox="1"/>
            <p:nvPr/>
          </p:nvSpPr>
          <p:spPr>
            <a:xfrm>
              <a:off x="4241101" y="946332"/>
              <a:ext cx="357338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C72DE38-C082-F02A-58DC-D04BCAB16A1B}"/>
                </a:ext>
              </a:extLst>
            </p:cNvPr>
            <p:cNvSpPr txBox="1"/>
            <p:nvPr/>
          </p:nvSpPr>
          <p:spPr>
            <a:xfrm>
              <a:off x="5743866" y="2430784"/>
              <a:ext cx="382464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E43F81D-CF00-EA80-9037-D2132D3D4EC8}"/>
                </a:ext>
              </a:extLst>
            </p:cNvPr>
            <p:cNvSpPr txBox="1"/>
            <p:nvPr/>
          </p:nvSpPr>
          <p:spPr>
            <a:xfrm>
              <a:off x="5751589" y="1910339"/>
              <a:ext cx="358659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E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C703E4A-76C3-6A33-A940-33BEEF70F7A8}"/>
                </a:ext>
              </a:extLst>
            </p:cNvPr>
            <p:cNvSpPr txBox="1"/>
            <p:nvPr/>
          </p:nvSpPr>
          <p:spPr>
            <a:xfrm>
              <a:off x="6633092" y="2978740"/>
              <a:ext cx="365273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d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B887DD1-E61E-3BC7-2EE1-6C12F6630379}"/>
                </a:ext>
              </a:extLst>
            </p:cNvPr>
            <p:cNvSpPr txBox="1"/>
            <p:nvPr/>
          </p:nvSpPr>
          <p:spPr>
            <a:xfrm>
              <a:off x="6646534" y="937271"/>
              <a:ext cx="357338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C148EB6-8040-7D63-6BFF-8E447C53DED6}"/>
                </a:ext>
              </a:extLst>
            </p:cNvPr>
            <p:cNvSpPr txBox="1"/>
            <p:nvPr/>
          </p:nvSpPr>
          <p:spPr>
            <a:xfrm>
              <a:off x="8057607" y="2249108"/>
              <a:ext cx="382464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BDA7EDB-A583-F3C3-9255-FA22C1E72D86}"/>
                </a:ext>
              </a:extLst>
            </p:cNvPr>
            <p:cNvSpPr txBox="1"/>
            <p:nvPr/>
          </p:nvSpPr>
          <p:spPr>
            <a:xfrm>
              <a:off x="8447142" y="1660015"/>
              <a:ext cx="358659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E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5006B36C-EEBA-8750-97ED-BE908A6FBB5F}"/>
                </a:ext>
              </a:extLst>
            </p:cNvPr>
            <p:cNvSpPr txBox="1"/>
            <p:nvPr/>
          </p:nvSpPr>
          <p:spPr>
            <a:xfrm>
              <a:off x="7214058" y="2547910"/>
              <a:ext cx="349403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F5DD68C-AD62-F808-0495-8E2C1546EDD7}"/>
                </a:ext>
              </a:extLst>
            </p:cNvPr>
            <p:cNvSpPr txBox="1"/>
            <p:nvPr/>
          </p:nvSpPr>
          <p:spPr>
            <a:xfrm>
              <a:off x="9106109" y="2638896"/>
              <a:ext cx="349403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A08BBD3-68F3-583C-D71B-BD8B500099EF}"/>
                </a:ext>
              </a:extLst>
            </p:cNvPr>
            <p:cNvSpPr txBox="1"/>
            <p:nvPr/>
          </p:nvSpPr>
          <p:spPr>
            <a:xfrm>
              <a:off x="9031046" y="2972649"/>
              <a:ext cx="365273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d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C570FCB-1CC5-54E9-2C0C-69D54CE2C256}"/>
                </a:ext>
              </a:extLst>
            </p:cNvPr>
            <p:cNvSpPr txBox="1"/>
            <p:nvPr/>
          </p:nvSpPr>
          <p:spPr>
            <a:xfrm>
              <a:off x="9044488" y="931179"/>
              <a:ext cx="357338" cy="259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E5A445DD-77ED-1C8E-A158-5ACA2539173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355097" y="2549389"/>
              <a:ext cx="53315" cy="136589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C49BF2A5-8FD5-5406-3725-443CB92C5C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85642" y="2439246"/>
              <a:ext cx="53315" cy="136589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5772FB7-D0E4-F709-AA9E-A8CBA7B4749A}"/>
                </a:ext>
              </a:extLst>
            </p:cNvPr>
            <p:cNvSpPr txBox="1"/>
            <p:nvPr/>
          </p:nvSpPr>
          <p:spPr>
            <a:xfrm>
              <a:off x="4905489" y="698106"/>
              <a:ext cx="16613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solidFill>
                    <a:srgbClr val="92D05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Whsc1    </a:t>
              </a:r>
              <a:r>
                <a:rPr lang="en-US" sz="1400" b="1" dirty="0">
                  <a:solidFill>
                    <a:srgbClr val="0000D9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3EB7C91-5059-872F-E6EF-8021E001F6B8}"/>
                </a:ext>
              </a:extLst>
            </p:cNvPr>
            <p:cNvSpPr txBox="1"/>
            <p:nvPr/>
          </p:nvSpPr>
          <p:spPr>
            <a:xfrm>
              <a:off x="2302138" y="685801"/>
              <a:ext cx="3442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A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0C12DC1-43EB-A558-165B-74C550B9CC9F}"/>
              </a:ext>
            </a:extLst>
          </p:cNvPr>
          <p:cNvGrpSpPr/>
          <p:nvPr/>
        </p:nvGrpSpPr>
        <p:grpSpPr>
          <a:xfrm>
            <a:off x="1798321" y="3127541"/>
            <a:ext cx="8141745" cy="3191741"/>
            <a:chOff x="1798321" y="3127541"/>
            <a:chExt cx="8141745" cy="3191741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242D8601-5050-9B23-C278-9EDB5F7A0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88207" y="3397105"/>
              <a:ext cx="4004449" cy="29068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4BA2932-6F8D-E90B-EE47-FD077673274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935616" y="3397107"/>
              <a:ext cx="4004450" cy="29068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173F133-42B5-DD00-683D-39203FE2A41E}"/>
                </a:ext>
              </a:extLst>
            </p:cNvPr>
            <p:cNvSpPr txBox="1"/>
            <p:nvPr/>
          </p:nvSpPr>
          <p:spPr>
            <a:xfrm>
              <a:off x="1888207" y="3423905"/>
              <a:ext cx="1003609" cy="249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16.5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C647857-C154-0A4F-7D4C-281B60DEBBB0}"/>
                </a:ext>
              </a:extLst>
            </p:cNvPr>
            <p:cNvSpPr txBox="1"/>
            <p:nvPr/>
          </p:nvSpPr>
          <p:spPr>
            <a:xfrm>
              <a:off x="5935616" y="3423905"/>
              <a:ext cx="1003609" cy="249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1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2496B03-2525-00B6-2C23-DF1EA1C6A1CF}"/>
                </a:ext>
              </a:extLst>
            </p:cNvPr>
            <p:cNvSpPr txBox="1"/>
            <p:nvPr/>
          </p:nvSpPr>
          <p:spPr>
            <a:xfrm>
              <a:off x="1899452" y="6011505"/>
              <a:ext cx="9835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0 </a:t>
              </a:r>
              <a:r>
                <a:rPr lang="el-GR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93647BE-4211-77CF-A11F-83B759CFD479}"/>
                </a:ext>
              </a:extLst>
            </p:cNvPr>
            <p:cNvSpPr txBox="1"/>
            <p:nvPr/>
          </p:nvSpPr>
          <p:spPr>
            <a:xfrm>
              <a:off x="5968839" y="6004344"/>
              <a:ext cx="8837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0 </a:t>
              </a:r>
              <a:r>
                <a:rPr lang="el-GR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BC6D4D4-1C66-831A-C565-9F6B350971F1}"/>
                </a:ext>
              </a:extLst>
            </p:cNvPr>
            <p:cNvSpPr txBox="1"/>
            <p:nvPr/>
          </p:nvSpPr>
          <p:spPr>
            <a:xfrm>
              <a:off x="3991965" y="5130041"/>
              <a:ext cx="326282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2FBB046-D03A-5514-2506-ACC24D2EBBFD}"/>
                </a:ext>
              </a:extLst>
            </p:cNvPr>
            <p:cNvSpPr txBox="1"/>
            <p:nvPr/>
          </p:nvSpPr>
          <p:spPr>
            <a:xfrm>
              <a:off x="3932349" y="4538019"/>
              <a:ext cx="305974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E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1DF8A1E-DF89-65A6-B538-0EB553CA8CAB}"/>
                </a:ext>
              </a:extLst>
            </p:cNvPr>
            <p:cNvSpPr txBox="1"/>
            <p:nvPr/>
          </p:nvSpPr>
          <p:spPr>
            <a:xfrm>
              <a:off x="2343642" y="5177709"/>
              <a:ext cx="29807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DB0DD28-31CC-D01E-CA1B-AF3504047F2E}"/>
                </a:ext>
              </a:extLst>
            </p:cNvPr>
            <p:cNvSpPr txBox="1"/>
            <p:nvPr/>
          </p:nvSpPr>
          <p:spPr>
            <a:xfrm>
              <a:off x="4648675" y="5508912"/>
              <a:ext cx="29807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3ADC262-EAAB-D485-AEAD-382C06A5810A}"/>
                </a:ext>
              </a:extLst>
            </p:cNvPr>
            <p:cNvSpPr txBox="1"/>
            <p:nvPr/>
          </p:nvSpPr>
          <p:spPr>
            <a:xfrm>
              <a:off x="5464147" y="5913166"/>
              <a:ext cx="311616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d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8B158DC-6315-0BF8-20E2-5F7D3613A7C0}"/>
                </a:ext>
              </a:extLst>
            </p:cNvPr>
            <p:cNvSpPr txBox="1"/>
            <p:nvPr/>
          </p:nvSpPr>
          <p:spPr>
            <a:xfrm>
              <a:off x="5498982" y="3414871"/>
              <a:ext cx="30484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8C91F5E-85D1-4D99-E9D3-B038C274A2ED}"/>
                </a:ext>
              </a:extLst>
            </p:cNvPr>
            <p:cNvSpPr txBox="1"/>
            <p:nvPr/>
          </p:nvSpPr>
          <p:spPr>
            <a:xfrm>
              <a:off x="9513382" y="5967881"/>
              <a:ext cx="311616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d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4049C73-EB16-EC78-78E9-D477CFB5EAAE}"/>
                </a:ext>
              </a:extLst>
            </p:cNvPr>
            <p:cNvSpPr txBox="1"/>
            <p:nvPr/>
          </p:nvSpPr>
          <p:spPr>
            <a:xfrm>
              <a:off x="6574832" y="5516492"/>
              <a:ext cx="29807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D009BFC-AC02-E191-226F-C7EEDA77C491}"/>
                </a:ext>
              </a:extLst>
            </p:cNvPr>
            <p:cNvSpPr txBox="1"/>
            <p:nvPr/>
          </p:nvSpPr>
          <p:spPr>
            <a:xfrm>
              <a:off x="8742796" y="5981400"/>
              <a:ext cx="29807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L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AA6173B-B67A-2B5F-36BB-4EDE1A221B4C}"/>
                </a:ext>
              </a:extLst>
            </p:cNvPr>
            <p:cNvSpPr txBox="1"/>
            <p:nvPr/>
          </p:nvSpPr>
          <p:spPr>
            <a:xfrm>
              <a:off x="8521077" y="5165406"/>
              <a:ext cx="326282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ADA551C-D011-F557-8858-C73560F4A8D8}"/>
                </a:ext>
              </a:extLst>
            </p:cNvPr>
            <p:cNvSpPr txBox="1"/>
            <p:nvPr/>
          </p:nvSpPr>
          <p:spPr>
            <a:xfrm>
              <a:off x="6657745" y="5130041"/>
              <a:ext cx="326282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M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ED26407-6B43-A528-E641-6AAD0230109A}"/>
                </a:ext>
              </a:extLst>
            </p:cNvPr>
            <p:cNvSpPr txBox="1"/>
            <p:nvPr/>
          </p:nvSpPr>
          <p:spPr>
            <a:xfrm>
              <a:off x="7151556" y="4093923"/>
              <a:ext cx="305974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86F2811-AD73-28BD-0A18-1029D3EB06C3}"/>
                </a:ext>
              </a:extLst>
            </p:cNvPr>
            <p:cNvSpPr txBox="1"/>
            <p:nvPr/>
          </p:nvSpPr>
          <p:spPr>
            <a:xfrm>
              <a:off x="5033282" y="3127541"/>
              <a:ext cx="15934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solidFill>
                    <a:srgbClr val="92D05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Whsc1    </a:t>
              </a:r>
              <a:r>
                <a:rPr lang="en-US" sz="1400" b="1" dirty="0">
                  <a:solidFill>
                    <a:srgbClr val="0000D9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07C0810B-1357-9CAE-534A-E0D801E770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27447" y="5033874"/>
              <a:ext cx="45484" cy="131532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>
              <a:extLst>
                <a:ext uri="{FF2B5EF4-FFF2-40B4-BE49-F238E27FC236}">
                  <a16:creationId xmlns:a16="http://schemas.microsoft.com/office/drawing/2014/main" id="{583A0051-9BC4-BDF2-FF7F-7CA86441B5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18326" y="5391204"/>
              <a:ext cx="31768" cy="140304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92">
              <a:extLst>
                <a:ext uri="{FF2B5EF4-FFF2-40B4-BE49-F238E27FC236}">
                  <a16:creationId xmlns:a16="http://schemas.microsoft.com/office/drawing/2014/main" id="{347E1F21-2484-80B7-AE3E-28232FC820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60968" y="5630890"/>
              <a:ext cx="121077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66034598-3D8E-2DA6-DF2F-FDCC5F3A99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031541" y="6042223"/>
              <a:ext cx="121077" cy="53995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1C603E6-2315-E858-1911-363444875D66}"/>
                </a:ext>
              </a:extLst>
            </p:cNvPr>
            <p:cNvSpPr txBox="1"/>
            <p:nvPr/>
          </p:nvSpPr>
          <p:spPr>
            <a:xfrm>
              <a:off x="9470346" y="3405906"/>
              <a:ext cx="304847" cy="249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en-US" altLang="zh-CN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</a:t>
              </a:r>
              <a:endParaRPr lang="en-US" sz="14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224FC81-FC71-F95E-96A4-55E413E6E1A1}"/>
                </a:ext>
              </a:extLst>
            </p:cNvPr>
            <p:cNvSpPr txBox="1"/>
            <p:nvPr/>
          </p:nvSpPr>
          <p:spPr>
            <a:xfrm>
              <a:off x="1798321" y="3151096"/>
              <a:ext cx="3442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B</a:t>
              </a:r>
            </a:p>
          </p:txBody>
        </p:sp>
      </p:grpSp>
      <p:grpSp>
        <p:nvGrpSpPr>
          <p:cNvPr id="176" name="Group 175">
            <a:extLst>
              <a:ext uri="{FF2B5EF4-FFF2-40B4-BE49-F238E27FC236}">
                <a16:creationId xmlns:a16="http://schemas.microsoft.com/office/drawing/2014/main" id="{4332EEAD-A081-BBBF-2001-2F9CFD50EEB3}"/>
              </a:ext>
            </a:extLst>
          </p:cNvPr>
          <p:cNvGrpSpPr/>
          <p:nvPr/>
        </p:nvGrpSpPr>
        <p:grpSpPr>
          <a:xfrm>
            <a:off x="1193536" y="6618434"/>
            <a:ext cx="10028412" cy="2354689"/>
            <a:chOff x="1193536" y="6618434"/>
            <a:chExt cx="10028412" cy="2354689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56E29C1-F7DE-2414-5187-B77D091F8D20}"/>
                </a:ext>
              </a:extLst>
            </p:cNvPr>
            <p:cNvGrpSpPr/>
            <p:nvPr/>
          </p:nvGrpSpPr>
          <p:grpSpPr>
            <a:xfrm>
              <a:off x="6409066" y="6653304"/>
              <a:ext cx="4812882" cy="2276728"/>
              <a:chOff x="6409066" y="2610078"/>
              <a:chExt cx="5782934" cy="2922131"/>
            </a:xfrm>
          </p:grpSpPr>
          <p:sp>
            <p:nvSpPr>
              <p:cNvPr id="13" name="Line 5">
                <a:extLst>
                  <a:ext uri="{FF2B5EF4-FFF2-40B4-BE49-F238E27FC236}">
                    <a16:creationId xmlns:a16="http://schemas.microsoft.com/office/drawing/2014/main" id="{0893878E-4593-6E7F-1BE6-6D0A9A210A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33868" y="4924653"/>
                <a:ext cx="3333750" cy="0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" name="Line 6">
                <a:extLst>
                  <a:ext uri="{FF2B5EF4-FFF2-40B4-BE49-F238E27FC236}">
                    <a16:creationId xmlns:a16="http://schemas.microsoft.com/office/drawing/2014/main" id="{4FEE2CAF-5E0B-8274-4B0C-1A632E23A3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4581" y="4924653"/>
                <a:ext cx="0" cy="93663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" name="Line 7">
                <a:extLst>
                  <a:ext uri="{FF2B5EF4-FFF2-40B4-BE49-F238E27FC236}">
                    <a16:creationId xmlns:a16="http://schemas.microsoft.com/office/drawing/2014/main" id="{7A02338B-D7AE-6DFA-775C-59977EAB69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65768" y="4924653"/>
                <a:ext cx="0" cy="93663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7" name="Line 8">
                <a:extLst>
                  <a:ext uri="{FF2B5EF4-FFF2-40B4-BE49-F238E27FC236}">
                    <a16:creationId xmlns:a16="http://schemas.microsoft.com/office/drawing/2014/main" id="{5FD04ED4-B194-9B2B-781A-81A5649686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6956" y="4924653"/>
                <a:ext cx="0" cy="93663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8" name="Line 9">
                <a:extLst>
                  <a:ext uri="{FF2B5EF4-FFF2-40B4-BE49-F238E27FC236}">
                    <a16:creationId xmlns:a16="http://schemas.microsoft.com/office/drawing/2014/main" id="{2C0E7F6A-7DCE-7DEF-8D22-EF99AAFFD5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89731" y="4924653"/>
                <a:ext cx="0" cy="93663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9" name="Line 10">
                <a:extLst>
                  <a:ext uri="{FF2B5EF4-FFF2-40B4-BE49-F238E27FC236}">
                    <a16:creationId xmlns:a16="http://schemas.microsoft.com/office/drawing/2014/main" id="{8E2581ED-A13A-495B-ECBB-309F6F27BD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00918" y="4924653"/>
                <a:ext cx="0" cy="93663"/>
              </a:xfrm>
              <a:prstGeom prst="line">
                <a:avLst/>
              </a:pr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20" name="Rectangle 11">
                <a:extLst>
                  <a:ext uri="{FF2B5EF4-FFF2-40B4-BE49-F238E27FC236}">
                    <a16:creationId xmlns:a16="http://schemas.microsoft.com/office/drawing/2014/main" id="{52C48233-C4DA-9BFA-C955-7863F19D8E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14793" y="4821465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" name="Rectangle 12">
                <a:extLst>
                  <a:ext uri="{FF2B5EF4-FFF2-40B4-BE49-F238E27FC236}">
                    <a16:creationId xmlns:a16="http://schemas.microsoft.com/office/drawing/2014/main" id="{10D05343-B828-3734-3194-339732420A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9531" y="4383315"/>
                <a:ext cx="2981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00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" name="Rectangle 13">
                <a:extLst>
                  <a:ext uri="{FF2B5EF4-FFF2-40B4-BE49-F238E27FC236}">
                    <a16:creationId xmlns:a16="http://schemas.microsoft.com/office/drawing/2014/main" id="{2FE15DB3-F00C-D49B-4C16-B4A4102198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9531" y="3934053"/>
                <a:ext cx="2981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00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" name="Rectangle 14">
                <a:extLst>
                  <a:ext uri="{FF2B5EF4-FFF2-40B4-BE49-F238E27FC236}">
                    <a16:creationId xmlns:a16="http://schemas.microsoft.com/office/drawing/2014/main" id="{CABBD7EF-CA7E-89F0-7EBA-CDC71813B2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9531" y="3497490"/>
                <a:ext cx="2981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00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" name="Rectangle 15">
                <a:extLst>
                  <a:ext uri="{FF2B5EF4-FFF2-40B4-BE49-F238E27FC236}">
                    <a16:creationId xmlns:a16="http://schemas.microsoft.com/office/drawing/2014/main" id="{8F92D077-84E2-05AA-CA99-5F39F62733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9531" y="3048228"/>
                <a:ext cx="2981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00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3" name="Rectangle 16">
                <a:extLst>
                  <a:ext uri="{FF2B5EF4-FFF2-40B4-BE49-F238E27FC236}">
                    <a16:creationId xmlns:a16="http://schemas.microsoft.com/office/drawing/2014/main" id="{EFD9CDCB-6E14-EC91-712F-CDD60873C5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7456" y="2610078"/>
                <a:ext cx="39754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000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" name="Freeform 17">
                <a:extLst>
                  <a:ext uri="{FF2B5EF4-FFF2-40B4-BE49-F238E27FC236}">
                    <a16:creationId xmlns:a16="http://schemas.microsoft.com/office/drawing/2014/main" id="{8EE0DA92-C5D7-C10B-55B8-677298449B0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051318" y="2702153"/>
                <a:ext cx="92075" cy="2233613"/>
              </a:xfrm>
              <a:custGeom>
                <a:avLst/>
                <a:gdLst>
                  <a:gd name="T0" fmla="*/ 58 w 58"/>
                  <a:gd name="T1" fmla="*/ 1407 h 1407"/>
                  <a:gd name="T2" fmla="*/ 58 w 58"/>
                  <a:gd name="T3" fmla="*/ 0 h 1407"/>
                  <a:gd name="T4" fmla="*/ 58 w 58"/>
                  <a:gd name="T5" fmla="*/ 1400 h 1407"/>
                  <a:gd name="T6" fmla="*/ 0 w 58"/>
                  <a:gd name="T7" fmla="*/ 1400 h 1407"/>
                  <a:gd name="T8" fmla="*/ 58 w 58"/>
                  <a:gd name="T9" fmla="*/ 1121 h 1407"/>
                  <a:gd name="T10" fmla="*/ 0 w 58"/>
                  <a:gd name="T11" fmla="*/ 1121 h 1407"/>
                  <a:gd name="T12" fmla="*/ 58 w 58"/>
                  <a:gd name="T13" fmla="*/ 843 h 1407"/>
                  <a:gd name="T14" fmla="*/ 0 w 58"/>
                  <a:gd name="T15" fmla="*/ 843 h 1407"/>
                  <a:gd name="T16" fmla="*/ 58 w 58"/>
                  <a:gd name="T17" fmla="*/ 564 h 1407"/>
                  <a:gd name="T18" fmla="*/ 0 w 58"/>
                  <a:gd name="T19" fmla="*/ 564 h 1407"/>
                  <a:gd name="T20" fmla="*/ 58 w 58"/>
                  <a:gd name="T21" fmla="*/ 286 h 1407"/>
                  <a:gd name="T22" fmla="*/ 0 w 58"/>
                  <a:gd name="T23" fmla="*/ 286 h 1407"/>
                  <a:gd name="T24" fmla="*/ 58 w 58"/>
                  <a:gd name="T25" fmla="*/ 7 h 1407"/>
                  <a:gd name="T26" fmla="*/ 0 w 58"/>
                  <a:gd name="T27" fmla="*/ 7 h 14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8" h="1407">
                    <a:moveTo>
                      <a:pt x="58" y="1407"/>
                    </a:moveTo>
                    <a:lnTo>
                      <a:pt x="58" y="0"/>
                    </a:lnTo>
                    <a:moveTo>
                      <a:pt x="58" y="1400"/>
                    </a:moveTo>
                    <a:lnTo>
                      <a:pt x="0" y="1400"/>
                    </a:lnTo>
                    <a:moveTo>
                      <a:pt x="58" y="1121"/>
                    </a:moveTo>
                    <a:lnTo>
                      <a:pt x="0" y="1121"/>
                    </a:lnTo>
                    <a:moveTo>
                      <a:pt x="58" y="843"/>
                    </a:moveTo>
                    <a:lnTo>
                      <a:pt x="0" y="843"/>
                    </a:lnTo>
                    <a:moveTo>
                      <a:pt x="58" y="564"/>
                    </a:moveTo>
                    <a:lnTo>
                      <a:pt x="0" y="564"/>
                    </a:lnTo>
                    <a:moveTo>
                      <a:pt x="58" y="286"/>
                    </a:moveTo>
                    <a:lnTo>
                      <a:pt x="0" y="286"/>
                    </a:lnTo>
                    <a:moveTo>
                      <a:pt x="58" y="7"/>
                    </a:moveTo>
                    <a:lnTo>
                      <a:pt x="0" y="7"/>
                    </a:lnTo>
                  </a:path>
                </a:pathLst>
              </a:custGeom>
              <a:noFill/>
              <a:ln w="222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36" name="Freeform 18">
                <a:extLst>
                  <a:ext uri="{FF2B5EF4-FFF2-40B4-BE49-F238E27FC236}">
                    <a16:creationId xmlns:a16="http://schemas.microsoft.com/office/drawing/2014/main" id="{4513D03D-ADA0-5B0D-07EB-A4B30D73B9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43393" y="3175228"/>
                <a:ext cx="3057525" cy="1727200"/>
              </a:xfrm>
              <a:custGeom>
                <a:avLst/>
                <a:gdLst>
                  <a:gd name="T0" fmla="*/ 0 w 1926"/>
                  <a:gd name="T1" fmla="*/ 1088 h 1088"/>
                  <a:gd name="T2" fmla="*/ 0 w 1926"/>
                  <a:gd name="T3" fmla="*/ 1088 h 1088"/>
                  <a:gd name="T4" fmla="*/ 0 w 1926"/>
                  <a:gd name="T5" fmla="*/ 1088 h 1088"/>
                  <a:gd name="T6" fmla="*/ 385 w 1926"/>
                  <a:gd name="T7" fmla="*/ 1080 h 1088"/>
                  <a:gd name="T8" fmla="*/ 385 w 1926"/>
                  <a:gd name="T9" fmla="*/ 1080 h 1088"/>
                  <a:gd name="T10" fmla="*/ 770 w 1926"/>
                  <a:gd name="T11" fmla="*/ 1037 h 1088"/>
                  <a:gd name="T12" fmla="*/ 770 w 1926"/>
                  <a:gd name="T13" fmla="*/ 1037 h 1088"/>
                  <a:gd name="T14" fmla="*/ 1155 w 1926"/>
                  <a:gd name="T15" fmla="*/ 876 h 1088"/>
                  <a:gd name="T16" fmla="*/ 1155 w 1926"/>
                  <a:gd name="T17" fmla="*/ 876 h 1088"/>
                  <a:gd name="T18" fmla="*/ 1541 w 1926"/>
                  <a:gd name="T19" fmla="*/ 468 h 1088"/>
                  <a:gd name="T20" fmla="*/ 1541 w 1926"/>
                  <a:gd name="T21" fmla="*/ 468 h 1088"/>
                  <a:gd name="T22" fmla="*/ 1926 w 1926"/>
                  <a:gd name="T23" fmla="*/ 0 h 10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926" h="1088">
                    <a:moveTo>
                      <a:pt x="0" y="1088"/>
                    </a:moveTo>
                    <a:lnTo>
                      <a:pt x="0" y="1088"/>
                    </a:lnTo>
                    <a:lnTo>
                      <a:pt x="0" y="1088"/>
                    </a:lnTo>
                    <a:lnTo>
                      <a:pt x="385" y="1080"/>
                    </a:lnTo>
                    <a:lnTo>
                      <a:pt x="385" y="1080"/>
                    </a:lnTo>
                    <a:lnTo>
                      <a:pt x="770" y="1037"/>
                    </a:lnTo>
                    <a:lnTo>
                      <a:pt x="770" y="1037"/>
                    </a:lnTo>
                    <a:lnTo>
                      <a:pt x="1155" y="876"/>
                    </a:lnTo>
                    <a:lnTo>
                      <a:pt x="1155" y="876"/>
                    </a:lnTo>
                    <a:lnTo>
                      <a:pt x="1541" y="468"/>
                    </a:lnTo>
                    <a:lnTo>
                      <a:pt x="1541" y="468"/>
                    </a:lnTo>
                    <a:lnTo>
                      <a:pt x="1926" y="0"/>
                    </a:lnTo>
                  </a:path>
                </a:pathLst>
              </a:cu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37" name="Line 19">
                <a:extLst>
                  <a:ext uri="{FF2B5EF4-FFF2-40B4-BE49-F238E27FC236}">
                    <a16:creationId xmlns:a16="http://schemas.microsoft.com/office/drawing/2014/main" id="{E92773DA-D87C-77A9-BAFA-F6C30166AB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89731" y="3856265"/>
                <a:ext cx="0" cy="61913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40" name="Line 20">
                <a:extLst>
                  <a:ext uri="{FF2B5EF4-FFF2-40B4-BE49-F238E27FC236}">
                    <a16:creationId xmlns:a16="http://schemas.microsoft.com/office/drawing/2014/main" id="{57265BD4-6FD1-6553-3EB5-767D5C1746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89731" y="3918178"/>
                <a:ext cx="0" cy="61913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41" name="Line 21">
                <a:extLst>
                  <a:ext uri="{FF2B5EF4-FFF2-40B4-BE49-F238E27FC236}">
                    <a16:creationId xmlns:a16="http://schemas.microsoft.com/office/drawing/2014/main" id="{096F4C2B-F36E-5719-A3C9-9FA5AE879A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45281" y="3856265"/>
                <a:ext cx="8890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56" name="Line 22">
                <a:extLst>
                  <a:ext uri="{FF2B5EF4-FFF2-40B4-BE49-F238E27FC236}">
                    <a16:creationId xmlns:a16="http://schemas.microsoft.com/office/drawing/2014/main" id="{B8A8F1A9-00F6-6C7B-60FD-8DE2F3FD5A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45281" y="3980090"/>
                <a:ext cx="8890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58" name="Line 23">
                <a:extLst>
                  <a:ext uri="{FF2B5EF4-FFF2-40B4-BE49-F238E27FC236}">
                    <a16:creationId xmlns:a16="http://schemas.microsoft.com/office/drawing/2014/main" id="{E82928C7-1DA8-A9F2-BC2F-2A052D6A59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00918" y="2903765"/>
                <a:ext cx="0" cy="271463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59" name="Line 24">
                <a:extLst>
                  <a:ext uri="{FF2B5EF4-FFF2-40B4-BE49-F238E27FC236}">
                    <a16:creationId xmlns:a16="http://schemas.microsoft.com/office/drawing/2014/main" id="{CD9843CB-EA3C-AE22-C456-BC74A1E911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00918" y="3175228"/>
                <a:ext cx="0" cy="27305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60" name="Line 25">
                <a:extLst>
                  <a:ext uri="{FF2B5EF4-FFF2-40B4-BE49-F238E27FC236}">
                    <a16:creationId xmlns:a16="http://schemas.microsoft.com/office/drawing/2014/main" id="{3576353F-2150-00D9-78D2-818EB1802C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156468" y="2903765"/>
                <a:ext cx="8890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73" name="Line 26">
                <a:extLst>
                  <a:ext uri="{FF2B5EF4-FFF2-40B4-BE49-F238E27FC236}">
                    <a16:creationId xmlns:a16="http://schemas.microsoft.com/office/drawing/2014/main" id="{01797523-7956-C28B-E780-98F8C8F8E9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156468" y="3448278"/>
                <a:ext cx="8890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0" name="Rectangle 27">
                <a:extLst>
                  <a:ext uri="{FF2B5EF4-FFF2-40B4-BE49-F238E27FC236}">
                    <a16:creationId xmlns:a16="http://schemas.microsoft.com/office/drawing/2014/main" id="{06F53B56-DA27-22FD-5BD9-E931D0AF1E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0531" y="4857978"/>
                <a:ext cx="87313" cy="889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4" name="Rectangle 28">
                <a:extLst>
                  <a:ext uri="{FF2B5EF4-FFF2-40B4-BE49-F238E27FC236}">
                    <a16:creationId xmlns:a16="http://schemas.microsoft.com/office/drawing/2014/main" id="{6C983C25-4020-35D8-007B-638C0895C0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0531" y="4857978"/>
                <a:ext cx="87313" cy="8890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5" name="Rectangle 29">
                <a:extLst>
                  <a:ext uri="{FF2B5EF4-FFF2-40B4-BE49-F238E27FC236}">
                    <a16:creationId xmlns:a16="http://schemas.microsoft.com/office/drawing/2014/main" id="{DED813CC-CBB8-9BEE-3A50-C7020DAB12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1718" y="4845278"/>
                <a:ext cx="87313" cy="889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6" name="Rectangle 30">
                <a:extLst>
                  <a:ext uri="{FF2B5EF4-FFF2-40B4-BE49-F238E27FC236}">
                    <a16:creationId xmlns:a16="http://schemas.microsoft.com/office/drawing/2014/main" id="{DB2E414D-661E-6A81-146E-F5E54C0C03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1718" y="4845278"/>
                <a:ext cx="87313" cy="8890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7" name="Rectangle 31">
                <a:extLst>
                  <a:ext uri="{FF2B5EF4-FFF2-40B4-BE49-F238E27FC236}">
                    <a16:creationId xmlns:a16="http://schemas.microsoft.com/office/drawing/2014/main" id="{CF3ACAA5-AF56-8439-34D3-3ED6AA9E55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22906" y="4777015"/>
                <a:ext cx="87313" cy="889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8" name="Rectangle 32">
                <a:extLst>
                  <a:ext uri="{FF2B5EF4-FFF2-40B4-BE49-F238E27FC236}">
                    <a16:creationId xmlns:a16="http://schemas.microsoft.com/office/drawing/2014/main" id="{ECEFCFFA-8478-3F91-8EFD-86CCF8EB30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22906" y="4777015"/>
                <a:ext cx="87313" cy="8890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89" name="Rectangle 33">
                <a:extLst>
                  <a:ext uri="{FF2B5EF4-FFF2-40B4-BE49-F238E27FC236}">
                    <a16:creationId xmlns:a16="http://schemas.microsoft.com/office/drawing/2014/main" id="{9C9A2E14-5064-935D-1EC6-1D1773D4F7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34093" y="4519840"/>
                <a:ext cx="87313" cy="889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0" name="Rectangle 34">
                <a:extLst>
                  <a:ext uri="{FF2B5EF4-FFF2-40B4-BE49-F238E27FC236}">
                    <a16:creationId xmlns:a16="http://schemas.microsoft.com/office/drawing/2014/main" id="{EDCEA4DF-16B5-2777-6139-6B26EEFEA2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34093" y="4519840"/>
                <a:ext cx="87313" cy="8890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1" name="Rectangle 35">
                <a:extLst>
                  <a:ext uri="{FF2B5EF4-FFF2-40B4-BE49-F238E27FC236}">
                    <a16:creationId xmlns:a16="http://schemas.microsoft.com/office/drawing/2014/main" id="{C3915DDC-9FC9-FEFE-64C7-2FE839DBE5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45281" y="3873728"/>
                <a:ext cx="88900" cy="889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2" name="Rectangle 36">
                <a:extLst>
                  <a:ext uri="{FF2B5EF4-FFF2-40B4-BE49-F238E27FC236}">
                    <a16:creationId xmlns:a16="http://schemas.microsoft.com/office/drawing/2014/main" id="{8E178B8F-5E33-2EE0-9A4F-90537D5250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45281" y="3873728"/>
                <a:ext cx="88900" cy="8890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4" name="Rectangle 37">
                <a:extLst>
                  <a:ext uri="{FF2B5EF4-FFF2-40B4-BE49-F238E27FC236}">
                    <a16:creationId xmlns:a16="http://schemas.microsoft.com/office/drawing/2014/main" id="{581C32EF-0782-0E12-4F83-8E4F53157D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6468" y="3132365"/>
                <a:ext cx="88900" cy="873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5" name="Rectangle 38">
                <a:extLst>
                  <a:ext uri="{FF2B5EF4-FFF2-40B4-BE49-F238E27FC236}">
                    <a16:creationId xmlns:a16="http://schemas.microsoft.com/office/drawing/2014/main" id="{FD081E2D-3D62-03E8-0B9A-58BF59632D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6468" y="3132365"/>
                <a:ext cx="88900" cy="8731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7" name="Freeform 39">
                <a:extLst>
                  <a:ext uri="{FF2B5EF4-FFF2-40B4-BE49-F238E27FC236}">
                    <a16:creationId xmlns:a16="http://schemas.microsoft.com/office/drawing/2014/main" id="{E000FCB3-A87C-4039-6206-D9A4CBF3AC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43393" y="4780190"/>
                <a:ext cx="3057525" cy="122238"/>
              </a:xfrm>
              <a:custGeom>
                <a:avLst/>
                <a:gdLst>
                  <a:gd name="T0" fmla="*/ 0 w 1926"/>
                  <a:gd name="T1" fmla="*/ 77 h 77"/>
                  <a:gd name="T2" fmla="*/ 0 w 1926"/>
                  <a:gd name="T3" fmla="*/ 77 h 77"/>
                  <a:gd name="T4" fmla="*/ 0 w 1926"/>
                  <a:gd name="T5" fmla="*/ 77 h 77"/>
                  <a:gd name="T6" fmla="*/ 385 w 1926"/>
                  <a:gd name="T7" fmla="*/ 74 h 77"/>
                  <a:gd name="T8" fmla="*/ 385 w 1926"/>
                  <a:gd name="T9" fmla="*/ 74 h 77"/>
                  <a:gd name="T10" fmla="*/ 770 w 1926"/>
                  <a:gd name="T11" fmla="*/ 68 h 77"/>
                  <a:gd name="T12" fmla="*/ 770 w 1926"/>
                  <a:gd name="T13" fmla="*/ 68 h 77"/>
                  <a:gd name="T14" fmla="*/ 1155 w 1926"/>
                  <a:gd name="T15" fmla="*/ 62 h 77"/>
                  <a:gd name="T16" fmla="*/ 1155 w 1926"/>
                  <a:gd name="T17" fmla="*/ 62 h 77"/>
                  <a:gd name="T18" fmla="*/ 1541 w 1926"/>
                  <a:gd name="T19" fmla="*/ 25 h 77"/>
                  <a:gd name="T20" fmla="*/ 1541 w 1926"/>
                  <a:gd name="T21" fmla="*/ 25 h 77"/>
                  <a:gd name="T22" fmla="*/ 1926 w 1926"/>
                  <a:gd name="T23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926" h="77">
                    <a:moveTo>
                      <a:pt x="0" y="77"/>
                    </a:moveTo>
                    <a:lnTo>
                      <a:pt x="0" y="77"/>
                    </a:lnTo>
                    <a:lnTo>
                      <a:pt x="0" y="77"/>
                    </a:lnTo>
                    <a:lnTo>
                      <a:pt x="385" y="74"/>
                    </a:lnTo>
                    <a:lnTo>
                      <a:pt x="385" y="74"/>
                    </a:lnTo>
                    <a:lnTo>
                      <a:pt x="770" y="68"/>
                    </a:lnTo>
                    <a:lnTo>
                      <a:pt x="770" y="68"/>
                    </a:lnTo>
                    <a:lnTo>
                      <a:pt x="1155" y="62"/>
                    </a:lnTo>
                    <a:lnTo>
                      <a:pt x="1155" y="62"/>
                    </a:lnTo>
                    <a:lnTo>
                      <a:pt x="1541" y="25"/>
                    </a:lnTo>
                    <a:lnTo>
                      <a:pt x="1541" y="25"/>
                    </a:lnTo>
                    <a:lnTo>
                      <a:pt x="1926" y="0"/>
                    </a:lnTo>
                  </a:path>
                </a:pathLst>
              </a:cu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8" name="Oval 40">
                <a:extLst>
                  <a:ext uri="{FF2B5EF4-FFF2-40B4-BE49-F238E27FC236}">
                    <a16:creationId xmlns:a16="http://schemas.microsoft.com/office/drawing/2014/main" id="{8FE794C2-EC0B-C378-AA53-9933F74B9E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0531" y="4857978"/>
                <a:ext cx="87313" cy="889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99" name="Oval 41">
                <a:extLst>
                  <a:ext uri="{FF2B5EF4-FFF2-40B4-BE49-F238E27FC236}">
                    <a16:creationId xmlns:a16="http://schemas.microsoft.com/office/drawing/2014/main" id="{DF006738-61BC-5155-E45F-D6F115EB5A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0531" y="4857978"/>
                <a:ext cx="87313" cy="889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0" name="Oval 42">
                <a:extLst>
                  <a:ext uri="{FF2B5EF4-FFF2-40B4-BE49-F238E27FC236}">
                    <a16:creationId xmlns:a16="http://schemas.microsoft.com/office/drawing/2014/main" id="{4C79A8DC-9424-FC24-E56C-A71BE5FA2D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1718" y="4851628"/>
                <a:ext cx="87313" cy="889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1" name="Oval 43">
                <a:extLst>
                  <a:ext uri="{FF2B5EF4-FFF2-40B4-BE49-F238E27FC236}">
                    <a16:creationId xmlns:a16="http://schemas.microsoft.com/office/drawing/2014/main" id="{E95A1598-EFD6-82B0-AC9D-2D68F75754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1718" y="4851628"/>
                <a:ext cx="87313" cy="889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2" name="Oval 44">
                <a:extLst>
                  <a:ext uri="{FF2B5EF4-FFF2-40B4-BE49-F238E27FC236}">
                    <a16:creationId xmlns:a16="http://schemas.microsoft.com/office/drawing/2014/main" id="{9FF63F08-FCB4-1E71-B46A-BE407FD59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22906" y="4843690"/>
                <a:ext cx="87313" cy="873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3" name="Oval 45">
                <a:extLst>
                  <a:ext uri="{FF2B5EF4-FFF2-40B4-BE49-F238E27FC236}">
                    <a16:creationId xmlns:a16="http://schemas.microsoft.com/office/drawing/2014/main" id="{45508130-B048-BFB9-ABC8-62FBA9522F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22906" y="4843690"/>
                <a:ext cx="87313" cy="873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4" name="Oval 46">
                <a:extLst>
                  <a:ext uri="{FF2B5EF4-FFF2-40B4-BE49-F238E27FC236}">
                    <a16:creationId xmlns:a16="http://schemas.microsoft.com/office/drawing/2014/main" id="{ACFA3645-9D53-9F8F-1F37-47032EC2F2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34093" y="4834165"/>
                <a:ext cx="87313" cy="873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5" name="Oval 47">
                <a:extLst>
                  <a:ext uri="{FF2B5EF4-FFF2-40B4-BE49-F238E27FC236}">
                    <a16:creationId xmlns:a16="http://schemas.microsoft.com/office/drawing/2014/main" id="{13A955D0-D54C-51D0-F9C2-AF52A5D813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34093" y="4834165"/>
                <a:ext cx="87313" cy="873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6" name="Oval 48">
                <a:extLst>
                  <a:ext uri="{FF2B5EF4-FFF2-40B4-BE49-F238E27FC236}">
                    <a16:creationId xmlns:a16="http://schemas.microsoft.com/office/drawing/2014/main" id="{C643E399-BF28-894B-506E-993316F2C5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45281" y="4775428"/>
                <a:ext cx="88900" cy="873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7" name="Oval 49">
                <a:extLst>
                  <a:ext uri="{FF2B5EF4-FFF2-40B4-BE49-F238E27FC236}">
                    <a16:creationId xmlns:a16="http://schemas.microsoft.com/office/drawing/2014/main" id="{62D4670F-88ED-97F6-EAB1-E2617A73FB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45281" y="4775428"/>
                <a:ext cx="88900" cy="873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8" name="Oval 50">
                <a:extLst>
                  <a:ext uri="{FF2B5EF4-FFF2-40B4-BE49-F238E27FC236}">
                    <a16:creationId xmlns:a16="http://schemas.microsoft.com/office/drawing/2014/main" id="{8E5BF51E-7C40-97B1-065F-0213941AE2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6468" y="4735740"/>
                <a:ext cx="88900" cy="889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09" name="Oval 51">
                <a:extLst>
                  <a:ext uri="{FF2B5EF4-FFF2-40B4-BE49-F238E27FC236}">
                    <a16:creationId xmlns:a16="http://schemas.microsoft.com/office/drawing/2014/main" id="{2D2D2E4D-F1C3-C717-1CC3-A40CD9FA88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6468" y="4735740"/>
                <a:ext cx="88900" cy="889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0" name="Rectangle 52">
                <a:extLst>
                  <a:ext uri="{FF2B5EF4-FFF2-40B4-BE49-F238E27FC236}">
                    <a16:creationId xmlns:a16="http://schemas.microsoft.com/office/drawing/2014/main" id="{A9CDC473-1121-CAA8-37DA-0EAFE9F338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29206" y="5316765"/>
                <a:ext cx="165910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hours post seeding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11" name="Rectangle 70">
                <a:extLst>
                  <a:ext uri="{FF2B5EF4-FFF2-40B4-BE49-F238E27FC236}">
                    <a16:creationId xmlns:a16="http://schemas.microsoft.com/office/drawing/2014/main" id="{63586F72-A262-043E-474B-4CCE8E2DAB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34393" y="2760890"/>
                <a:ext cx="31899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LS8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12" name="Line 71">
                <a:extLst>
                  <a:ext uri="{FF2B5EF4-FFF2-40B4-BE49-F238E27FC236}">
                    <a16:creationId xmlns:a16="http://schemas.microsoft.com/office/drawing/2014/main" id="{79B6E1D4-0D0A-21B1-042E-DF23FCF319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61331" y="2868840"/>
                <a:ext cx="23495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3" name="Oval 72">
                <a:extLst>
                  <a:ext uri="{FF2B5EF4-FFF2-40B4-BE49-F238E27FC236}">
                    <a16:creationId xmlns:a16="http://schemas.microsoft.com/office/drawing/2014/main" id="{E2C806D6-BEEA-F48F-7168-058A6AB7FE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34356" y="2824390"/>
                <a:ext cx="88900" cy="873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4" name="Oval 73">
                <a:extLst>
                  <a:ext uri="{FF2B5EF4-FFF2-40B4-BE49-F238E27FC236}">
                    <a16:creationId xmlns:a16="http://schemas.microsoft.com/office/drawing/2014/main" id="{DD7930C1-306F-AE1F-16C6-A942B6B504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34356" y="2824390"/>
                <a:ext cx="88900" cy="873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5" name="Rectangle 74">
                <a:extLst>
                  <a:ext uri="{FF2B5EF4-FFF2-40B4-BE49-F238E27FC236}">
                    <a16:creationId xmlns:a16="http://schemas.microsoft.com/office/drawing/2014/main" id="{C0C8D8BC-5DC0-CA21-A287-FDF82C7326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34393" y="3072040"/>
                <a:ext cx="8576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LS8-</a:t>
                </a:r>
                <a:r>
                  <a:rPr kumimoji="0" lang="en-US" altLang="en-US" sz="14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NSD2</a:t>
                </a:r>
                <a:endParaRPr kumimoji="0" lang="en-US" altLang="en-US" sz="1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16" name="Line 75">
                <a:extLst>
                  <a:ext uri="{FF2B5EF4-FFF2-40B4-BE49-F238E27FC236}">
                    <a16:creationId xmlns:a16="http://schemas.microsoft.com/office/drawing/2014/main" id="{132C0589-457A-F17B-4CC9-9BED308ADC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61331" y="3178403"/>
                <a:ext cx="23495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7" name="Rectangle 76">
                <a:extLst>
                  <a:ext uri="{FF2B5EF4-FFF2-40B4-BE49-F238E27FC236}">
                    <a16:creationId xmlns:a16="http://schemas.microsoft.com/office/drawing/2014/main" id="{99199E61-61DB-2BED-2526-80B5D03B54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34356" y="3133953"/>
                <a:ext cx="88900" cy="873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8" name="Rectangle 77">
                <a:extLst>
                  <a:ext uri="{FF2B5EF4-FFF2-40B4-BE49-F238E27FC236}">
                    <a16:creationId xmlns:a16="http://schemas.microsoft.com/office/drawing/2014/main" id="{B972C5C6-C7FD-19D4-D542-07744C0583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34356" y="3133953"/>
                <a:ext cx="88900" cy="8731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19" name="Rectangle 78">
                <a:extLst>
                  <a:ext uri="{FF2B5EF4-FFF2-40B4-BE49-F238E27FC236}">
                    <a16:creationId xmlns:a16="http://schemas.microsoft.com/office/drawing/2014/main" id="{1AD57A07-1D44-13E2-22B1-93C1E8102D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9643" y="5051653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4h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0" name="Rectangle 79">
                <a:extLst>
                  <a:ext uri="{FF2B5EF4-FFF2-40B4-BE49-F238E27FC236}">
                    <a16:creationId xmlns:a16="http://schemas.microsoft.com/office/drawing/2014/main" id="{9BFE2E92-472B-E3F9-32DB-4B983D6860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29243" y="5051653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8h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1" name="Rectangle 80">
                <a:extLst>
                  <a:ext uri="{FF2B5EF4-FFF2-40B4-BE49-F238E27FC236}">
                    <a16:creationId xmlns:a16="http://schemas.microsoft.com/office/drawing/2014/main" id="{41CF37D7-3069-631D-9013-2553369B86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38843" y="5051653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2h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2" name="Rectangle 81">
                <a:extLst>
                  <a:ext uri="{FF2B5EF4-FFF2-40B4-BE49-F238E27FC236}">
                    <a16:creationId xmlns:a16="http://schemas.microsoft.com/office/drawing/2014/main" id="{16B02304-5EDA-7308-90E5-A24AD03D90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48443" y="5051653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6h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3" name="Freeform 85">
                <a:extLst>
                  <a:ext uri="{FF2B5EF4-FFF2-40B4-BE49-F238E27FC236}">
                    <a16:creationId xmlns:a16="http://schemas.microsoft.com/office/drawing/2014/main" id="{36992F99-4533-7D3C-BA37-CDF442E817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05618" y="3903890"/>
                <a:ext cx="66675" cy="923925"/>
              </a:xfrm>
              <a:custGeom>
                <a:avLst/>
                <a:gdLst>
                  <a:gd name="T0" fmla="*/ 0 w 42"/>
                  <a:gd name="T1" fmla="*/ 0 h 582"/>
                  <a:gd name="T2" fmla="*/ 42 w 42"/>
                  <a:gd name="T3" fmla="*/ 0 h 582"/>
                  <a:gd name="T4" fmla="*/ 42 w 42"/>
                  <a:gd name="T5" fmla="*/ 582 h 582"/>
                  <a:gd name="T6" fmla="*/ 0 w 42"/>
                  <a:gd name="T7" fmla="*/ 582 h 5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582">
                    <a:moveTo>
                      <a:pt x="0" y="0"/>
                    </a:moveTo>
                    <a:lnTo>
                      <a:pt x="42" y="0"/>
                    </a:lnTo>
                    <a:lnTo>
                      <a:pt x="42" y="582"/>
                    </a:lnTo>
                    <a:lnTo>
                      <a:pt x="0" y="582"/>
                    </a:lnTo>
                  </a:path>
                </a:pathLst>
              </a:custGeom>
              <a:noFill/>
              <a:ln w="333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24" name="Rectangle 86">
                <a:extLst>
                  <a:ext uri="{FF2B5EF4-FFF2-40B4-BE49-F238E27FC236}">
                    <a16:creationId xmlns:a16="http://schemas.microsoft.com/office/drawing/2014/main" id="{87B248A6-CD2F-F46A-7889-B6CA4B3BA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35793" y="4280128"/>
                <a:ext cx="35907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****</a:t>
                </a:r>
                <a:endParaRPr kumimoji="0" lang="en-US" altLang="en-US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5" name="Freeform 87">
                <a:extLst>
                  <a:ext uri="{FF2B5EF4-FFF2-40B4-BE49-F238E27FC236}">
                    <a16:creationId xmlns:a16="http://schemas.microsoft.com/office/drawing/2014/main" id="{E359BD48-4477-EB47-A84B-2180BE318C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343793" y="3178403"/>
                <a:ext cx="66675" cy="1563688"/>
              </a:xfrm>
              <a:custGeom>
                <a:avLst/>
                <a:gdLst>
                  <a:gd name="T0" fmla="*/ 0 w 42"/>
                  <a:gd name="T1" fmla="*/ 0 h 985"/>
                  <a:gd name="T2" fmla="*/ 42 w 42"/>
                  <a:gd name="T3" fmla="*/ 0 h 985"/>
                  <a:gd name="T4" fmla="*/ 42 w 42"/>
                  <a:gd name="T5" fmla="*/ 985 h 985"/>
                  <a:gd name="T6" fmla="*/ 0 w 42"/>
                  <a:gd name="T7" fmla="*/ 985 h 9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985">
                    <a:moveTo>
                      <a:pt x="0" y="0"/>
                    </a:moveTo>
                    <a:lnTo>
                      <a:pt x="42" y="0"/>
                    </a:lnTo>
                    <a:lnTo>
                      <a:pt x="42" y="985"/>
                    </a:lnTo>
                    <a:lnTo>
                      <a:pt x="0" y="985"/>
                    </a:lnTo>
                  </a:path>
                </a:pathLst>
              </a:custGeom>
              <a:noFill/>
              <a:ln w="333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26" name="Rectangle 89">
                <a:extLst>
                  <a:ext uri="{FF2B5EF4-FFF2-40B4-BE49-F238E27FC236}">
                    <a16:creationId xmlns:a16="http://schemas.microsoft.com/office/drawing/2014/main" id="{D9A1A7D6-9D0E-887E-8541-CE1BD82862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23118" y="5051653"/>
                <a:ext cx="40716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20h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7" name="Rectangle 52">
                <a:extLst>
                  <a:ext uri="{FF2B5EF4-FFF2-40B4-BE49-F238E27FC236}">
                    <a16:creationId xmlns:a16="http://schemas.microsoft.com/office/drawing/2014/main" id="{3F0C3A76-5559-8F33-478A-8ED890CC60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5801848" y="3643768"/>
                <a:ext cx="142987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  <a:cs typeface="Times New Roman" panose="02020603050405020304" pitchFamily="18" charset="0"/>
                  </a:rPr>
                  <a:t>Cell Count (x10</a:t>
                </a:r>
                <a:r>
                  <a:rPr kumimoji="0" lang="en-US" altLang="en-US" sz="1400" b="1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  <a:cs typeface="Times New Roman" panose="02020603050405020304" pitchFamily="18" charset="0"/>
                  </a:rPr>
                  <a:t>4</a:t>
                </a:r>
                <a:r>
                  <a:rPr lang="en-US" altLang="en-US" sz="1400" b="1" dirty="0">
                    <a:solidFill>
                      <a:srgbClr val="000000"/>
                    </a:solidFill>
                    <a:latin typeface="Helvetica" pitchFamily="2" charset="0"/>
                    <a:cs typeface="Times New Roman" panose="02020603050405020304" pitchFamily="18" charset="0"/>
                  </a:rPr>
                  <a:t>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Rectangle 86">
                <a:extLst>
                  <a:ext uri="{FF2B5EF4-FFF2-40B4-BE49-F238E27FC236}">
                    <a16:creationId xmlns:a16="http://schemas.microsoft.com/office/drawing/2014/main" id="{4E546187-F68F-165A-3F1E-4C7879497D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87127" y="3873728"/>
                <a:ext cx="35907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****</a:t>
                </a:r>
                <a:endParaRPr kumimoji="0" lang="en-US" altLang="en-US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902CD122-0F32-2046-5967-68DB6E52DF11}"/>
                </a:ext>
              </a:extLst>
            </p:cNvPr>
            <p:cNvGrpSpPr/>
            <p:nvPr/>
          </p:nvGrpSpPr>
          <p:grpSpPr>
            <a:xfrm>
              <a:off x="1500794" y="6788075"/>
              <a:ext cx="3835000" cy="2185048"/>
              <a:chOff x="734338" y="2825749"/>
              <a:chExt cx="4607957" cy="2804463"/>
            </a:xfrm>
          </p:grpSpPr>
          <p:sp>
            <p:nvSpPr>
              <p:cNvPr id="130" name="Line 93">
                <a:extLst>
                  <a:ext uri="{FF2B5EF4-FFF2-40B4-BE49-F238E27FC236}">
                    <a16:creationId xmlns:a16="http://schemas.microsoft.com/office/drawing/2014/main" id="{967D6945-1528-71A3-0EC0-FA83BA336C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24013" y="4968875"/>
                <a:ext cx="206057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31" name="Line 94">
                <a:extLst>
                  <a:ext uri="{FF2B5EF4-FFF2-40B4-BE49-F238E27FC236}">
                    <a16:creationId xmlns:a16="http://schemas.microsoft.com/office/drawing/2014/main" id="{1BF6FB71-F044-92C9-3BAB-91D5ECC7A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8325" y="4968875"/>
                <a:ext cx="0" cy="87313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32" name="Line 95">
                <a:extLst>
                  <a:ext uri="{FF2B5EF4-FFF2-40B4-BE49-F238E27FC236}">
                    <a16:creationId xmlns:a16="http://schemas.microsoft.com/office/drawing/2014/main" id="{1E3C2F30-C68E-008C-7788-A10E492236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1100" y="4968875"/>
                <a:ext cx="0" cy="87313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33" name="Line 96">
                <a:extLst>
                  <a:ext uri="{FF2B5EF4-FFF2-40B4-BE49-F238E27FC236}">
                    <a16:creationId xmlns:a16="http://schemas.microsoft.com/office/drawing/2014/main" id="{77837CDD-FD0D-BFAB-CCF1-F40D961F11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076" y="4968875"/>
                <a:ext cx="0" cy="87313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34" name="Rectangle 97">
                <a:extLst>
                  <a:ext uri="{FF2B5EF4-FFF2-40B4-BE49-F238E27FC236}">
                    <a16:creationId xmlns:a16="http://schemas.microsoft.com/office/drawing/2014/main" id="{DBC8B9AE-A27A-EA92-8A85-5F63DFAE71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9522" y="4867274"/>
                <a:ext cx="2484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0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5" name="Rectangle 98">
                <a:extLst>
                  <a:ext uri="{FF2B5EF4-FFF2-40B4-BE49-F238E27FC236}">
                    <a16:creationId xmlns:a16="http://schemas.microsoft.com/office/drawing/2014/main" id="{5DA16B7B-2BDE-4814-9433-5F7C6E3F8E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9522" y="4187824"/>
                <a:ext cx="2484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2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6" name="Rectangle 99">
                <a:extLst>
                  <a:ext uri="{FF2B5EF4-FFF2-40B4-BE49-F238E27FC236}">
                    <a16:creationId xmlns:a16="http://schemas.microsoft.com/office/drawing/2014/main" id="{048CB85E-7524-E5D3-3B1F-A3D9619AE2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9522" y="3506787"/>
                <a:ext cx="2484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4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7" name="Rectangle 100">
                <a:extLst>
                  <a:ext uri="{FF2B5EF4-FFF2-40B4-BE49-F238E27FC236}">
                    <a16:creationId xmlns:a16="http://schemas.microsoft.com/office/drawing/2014/main" id="{C63EC6C4-18E9-4AC5-73BA-82823CC586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9522" y="2825749"/>
                <a:ext cx="2484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6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8" name="Freeform 101">
                <a:extLst>
                  <a:ext uri="{FF2B5EF4-FFF2-40B4-BE49-F238E27FC236}">
                    <a16:creationId xmlns:a16="http://schemas.microsoft.com/office/drawing/2014/main" id="{8B5EEB03-3928-748C-6AE3-54CB6C8BA1C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547813" y="2917825"/>
                <a:ext cx="85725" cy="2062163"/>
              </a:xfrm>
              <a:custGeom>
                <a:avLst/>
                <a:gdLst>
                  <a:gd name="T0" fmla="*/ 54 w 54"/>
                  <a:gd name="T1" fmla="*/ 1299 h 1299"/>
                  <a:gd name="T2" fmla="*/ 54 w 54"/>
                  <a:gd name="T3" fmla="*/ 0 h 1299"/>
                  <a:gd name="T4" fmla="*/ 54 w 54"/>
                  <a:gd name="T5" fmla="*/ 1292 h 1299"/>
                  <a:gd name="T6" fmla="*/ 0 w 54"/>
                  <a:gd name="T7" fmla="*/ 1292 h 1299"/>
                  <a:gd name="T8" fmla="*/ 54 w 54"/>
                  <a:gd name="T9" fmla="*/ 864 h 1299"/>
                  <a:gd name="T10" fmla="*/ 0 w 54"/>
                  <a:gd name="T11" fmla="*/ 864 h 1299"/>
                  <a:gd name="T12" fmla="*/ 54 w 54"/>
                  <a:gd name="T13" fmla="*/ 435 h 1299"/>
                  <a:gd name="T14" fmla="*/ 0 w 54"/>
                  <a:gd name="T15" fmla="*/ 435 h 1299"/>
                  <a:gd name="T16" fmla="*/ 54 w 54"/>
                  <a:gd name="T17" fmla="*/ 6 h 1299"/>
                  <a:gd name="T18" fmla="*/ 0 w 54"/>
                  <a:gd name="T19" fmla="*/ 6 h 12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54" h="1299">
                    <a:moveTo>
                      <a:pt x="54" y="1299"/>
                    </a:moveTo>
                    <a:lnTo>
                      <a:pt x="54" y="0"/>
                    </a:lnTo>
                    <a:moveTo>
                      <a:pt x="54" y="1292"/>
                    </a:moveTo>
                    <a:lnTo>
                      <a:pt x="0" y="1292"/>
                    </a:lnTo>
                    <a:moveTo>
                      <a:pt x="54" y="864"/>
                    </a:moveTo>
                    <a:lnTo>
                      <a:pt x="0" y="864"/>
                    </a:lnTo>
                    <a:moveTo>
                      <a:pt x="54" y="435"/>
                    </a:moveTo>
                    <a:lnTo>
                      <a:pt x="0" y="435"/>
                    </a:lnTo>
                    <a:moveTo>
                      <a:pt x="54" y="6"/>
                    </a:moveTo>
                    <a:lnTo>
                      <a:pt x="0" y="6"/>
                    </a:lnTo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39" name="Freeform 102">
                <a:extLst>
                  <a:ext uri="{FF2B5EF4-FFF2-40B4-BE49-F238E27FC236}">
                    <a16:creationId xmlns:a16="http://schemas.microsoft.com/office/drawing/2014/main" id="{33BD980D-F62D-871C-B9DC-30D4AB14B0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8325" y="3446463"/>
                <a:ext cx="1428750" cy="1249363"/>
              </a:xfrm>
              <a:custGeom>
                <a:avLst/>
                <a:gdLst>
                  <a:gd name="T0" fmla="*/ 0 w 900"/>
                  <a:gd name="T1" fmla="*/ 787 h 787"/>
                  <a:gd name="T2" fmla="*/ 0 w 900"/>
                  <a:gd name="T3" fmla="*/ 787 h 787"/>
                  <a:gd name="T4" fmla="*/ 0 w 900"/>
                  <a:gd name="T5" fmla="*/ 787 h 787"/>
                  <a:gd name="T6" fmla="*/ 386 w 900"/>
                  <a:gd name="T7" fmla="*/ 607 h 787"/>
                  <a:gd name="T8" fmla="*/ 386 w 900"/>
                  <a:gd name="T9" fmla="*/ 607 h 787"/>
                  <a:gd name="T10" fmla="*/ 900 w 900"/>
                  <a:gd name="T11" fmla="*/ 0 h 7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0" h="787">
                    <a:moveTo>
                      <a:pt x="0" y="787"/>
                    </a:moveTo>
                    <a:lnTo>
                      <a:pt x="0" y="787"/>
                    </a:lnTo>
                    <a:lnTo>
                      <a:pt x="0" y="787"/>
                    </a:lnTo>
                    <a:lnTo>
                      <a:pt x="386" y="607"/>
                    </a:lnTo>
                    <a:lnTo>
                      <a:pt x="386" y="607"/>
                    </a:lnTo>
                    <a:lnTo>
                      <a:pt x="900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0" name="Line 103">
                <a:extLst>
                  <a:ext uri="{FF2B5EF4-FFF2-40B4-BE49-F238E27FC236}">
                    <a16:creationId xmlns:a16="http://schemas.microsoft.com/office/drawing/2014/main" id="{808B235F-49A5-B4E1-33AC-6F38F1F964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076" y="3309938"/>
                <a:ext cx="0" cy="1365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1" name="Line 104">
                <a:extLst>
                  <a:ext uri="{FF2B5EF4-FFF2-40B4-BE49-F238E27FC236}">
                    <a16:creationId xmlns:a16="http://schemas.microsoft.com/office/drawing/2014/main" id="{30D39FE3-7650-466C-8044-F5FEA252E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076" y="3446463"/>
                <a:ext cx="0" cy="1365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2" name="Line 105">
                <a:extLst>
                  <a:ext uri="{FF2B5EF4-FFF2-40B4-BE49-F238E27FC236}">
                    <a16:creationId xmlns:a16="http://schemas.microsoft.com/office/drawing/2014/main" id="{440233C1-13F1-232D-364A-09445D4725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5801" y="3309938"/>
                <a:ext cx="80963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3" name="Line 106">
                <a:extLst>
                  <a:ext uri="{FF2B5EF4-FFF2-40B4-BE49-F238E27FC236}">
                    <a16:creationId xmlns:a16="http://schemas.microsoft.com/office/drawing/2014/main" id="{D488E535-0E06-13DC-940E-D735554746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5801" y="3582988"/>
                <a:ext cx="80963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4" name="Rectangle 107">
                <a:extLst>
                  <a:ext uri="{FF2B5EF4-FFF2-40B4-BE49-F238E27FC236}">
                    <a16:creationId xmlns:a16="http://schemas.microsoft.com/office/drawing/2014/main" id="{987EDA88-2723-4EC7-F383-895A31C3E4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050" y="4654550"/>
                <a:ext cx="82550" cy="809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5" name="Rectangle 108">
                <a:extLst>
                  <a:ext uri="{FF2B5EF4-FFF2-40B4-BE49-F238E27FC236}">
                    <a16:creationId xmlns:a16="http://schemas.microsoft.com/office/drawing/2014/main" id="{2443C1FE-34FB-CF77-67B4-14937D4575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050" y="4654550"/>
                <a:ext cx="82550" cy="809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6" name="Rectangle 109">
                <a:extLst>
                  <a:ext uri="{FF2B5EF4-FFF2-40B4-BE49-F238E27FC236}">
                    <a16:creationId xmlns:a16="http://schemas.microsoft.com/office/drawing/2014/main" id="{BDB67A6A-D324-28E5-48E4-5185BEC416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9825" y="4368800"/>
                <a:ext cx="80963" cy="809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7" name="Rectangle 110">
                <a:extLst>
                  <a:ext uri="{FF2B5EF4-FFF2-40B4-BE49-F238E27FC236}">
                    <a16:creationId xmlns:a16="http://schemas.microsoft.com/office/drawing/2014/main" id="{B9B6098D-F554-D815-AED8-ADB3341015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9825" y="4368800"/>
                <a:ext cx="80963" cy="809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8" name="Rectangle 111">
                <a:extLst>
                  <a:ext uri="{FF2B5EF4-FFF2-40B4-BE49-F238E27FC236}">
                    <a16:creationId xmlns:a16="http://schemas.microsoft.com/office/drawing/2014/main" id="{12D4D274-5F7E-9B24-79DF-675471CE19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5801" y="3405188"/>
                <a:ext cx="80963" cy="825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49" name="Rectangle 112">
                <a:extLst>
                  <a:ext uri="{FF2B5EF4-FFF2-40B4-BE49-F238E27FC236}">
                    <a16:creationId xmlns:a16="http://schemas.microsoft.com/office/drawing/2014/main" id="{EE988168-C4FA-0CA0-0DD5-8FA0472D34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5801" y="3405188"/>
                <a:ext cx="80963" cy="8255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0" name="Freeform 113">
                <a:extLst>
                  <a:ext uri="{FF2B5EF4-FFF2-40B4-BE49-F238E27FC236}">
                    <a16:creationId xmlns:a16="http://schemas.microsoft.com/office/drawing/2014/main" id="{FEC71DBB-C2BF-578B-CB4D-DA4FCAEB24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8325" y="4424363"/>
                <a:ext cx="1428750" cy="368300"/>
              </a:xfrm>
              <a:custGeom>
                <a:avLst/>
                <a:gdLst>
                  <a:gd name="T0" fmla="*/ 0 w 900"/>
                  <a:gd name="T1" fmla="*/ 232 h 232"/>
                  <a:gd name="T2" fmla="*/ 0 w 900"/>
                  <a:gd name="T3" fmla="*/ 232 h 232"/>
                  <a:gd name="T4" fmla="*/ 0 w 900"/>
                  <a:gd name="T5" fmla="*/ 232 h 232"/>
                  <a:gd name="T6" fmla="*/ 386 w 900"/>
                  <a:gd name="T7" fmla="*/ 146 h 232"/>
                  <a:gd name="T8" fmla="*/ 386 w 900"/>
                  <a:gd name="T9" fmla="*/ 146 h 232"/>
                  <a:gd name="T10" fmla="*/ 900 w 900"/>
                  <a:gd name="T11" fmla="*/ 0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0" h="232">
                    <a:moveTo>
                      <a:pt x="0" y="232"/>
                    </a:moveTo>
                    <a:lnTo>
                      <a:pt x="0" y="232"/>
                    </a:lnTo>
                    <a:lnTo>
                      <a:pt x="0" y="232"/>
                    </a:lnTo>
                    <a:lnTo>
                      <a:pt x="386" y="146"/>
                    </a:lnTo>
                    <a:lnTo>
                      <a:pt x="386" y="146"/>
                    </a:lnTo>
                    <a:lnTo>
                      <a:pt x="900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1" name="Oval 114">
                <a:extLst>
                  <a:ext uri="{FF2B5EF4-FFF2-40B4-BE49-F238E27FC236}">
                    <a16:creationId xmlns:a16="http://schemas.microsoft.com/office/drawing/2014/main" id="{D51D0BDD-4B0B-72A6-9601-90EB04790F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050" y="4751388"/>
                <a:ext cx="82550" cy="825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2" name="Oval 115">
                <a:extLst>
                  <a:ext uri="{FF2B5EF4-FFF2-40B4-BE49-F238E27FC236}">
                    <a16:creationId xmlns:a16="http://schemas.microsoft.com/office/drawing/2014/main" id="{07E0B540-6286-B641-3577-83C5F5C84C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050" y="4751388"/>
                <a:ext cx="82550" cy="825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3" name="Oval 116">
                <a:extLst>
                  <a:ext uri="{FF2B5EF4-FFF2-40B4-BE49-F238E27FC236}">
                    <a16:creationId xmlns:a16="http://schemas.microsoft.com/office/drawing/2014/main" id="{717C4407-055F-154C-7619-8DDDF4F114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9825" y="4616450"/>
                <a:ext cx="80963" cy="809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4" name="Oval 117">
                <a:extLst>
                  <a:ext uri="{FF2B5EF4-FFF2-40B4-BE49-F238E27FC236}">
                    <a16:creationId xmlns:a16="http://schemas.microsoft.com/office/drawing/2014/main" id="{EB58EE0C-96AC-5313-2FA9-5A6CF74F2E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9825" y="4616450"/>
                <a:ext cx="80963" cy="809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5" name="Oval 118">
                <a:extLst>
                  <a:ext uri="{FF2B5EF4-FFF2-40B4-BE49-F238E27FC236}">
                    <a16:creationId xmlns:a16="http://schemas.microsoft.com/office/drawing/2014/main" id="{7EF090B3-18A1-284C-9F04-7B39D7ADF5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5801" y="4384675"/>
                <a:ext cx="80963" cy="809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6" name="Oval 119">
                <a:extLst>
                  <a:ext uri="{FF2B5EF4-FFF2-40B4-BE49-F238E27FC236}">
                    <a16:creationId xmlns:a16="http://schemas.microsoft.com/office/drawing/2014/main" id="{B604576A-BB17-379E-CF7C-AA65320D5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5801" y="4383088"/>
                <a:ext cx="80963" cy="825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57" name="Rectangle 121">
                <a:extLst>
                  <a:ext uri="{FF2B5EF4-FFF2-40B4-BE49-F238E27FC236}">
                    <a16:creationId xmlns:a16="http://schemas.microsoft.com/office/drawing/2014/main" id="{9678CE3D-B236-973D-977E-33356F7A3B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9790" y="5353694"/>
                <a:ext cx="2318212" cy="2765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hours post seeding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8" name="Rectangle 152">
                <a:extLst>
                  <a:ext uri="{FF2B5EF4-FFF2-40B4-BE49-F238E27FC236}">
                    <a16:creationId xmlns:a16="http://schemas.microsoft.com/office/drawing/2014/main" id="{CC0113A7-F1A9-9BB1-068A-8D82301AB5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4688" y="2974975"/>
                <a:ext cx="31899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LS8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9" name="Line 153">
                <a:extLst>
                  <a:ext uri="{FF2B5EF4-FFF2-40B4-BE49-F238E27FC236}">
                    <a16:creationId xmlns:a16="http://schemas.microsoft.com/office/drawing/2014/main" id="{4CFA072F-56D3-C7D0-499D-3B176F8C7D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0201" y="3070225"/>
                <a:ext cx="21748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0" name="Oval 154">
                <a:extLst>
                  <a:ext uri="{FF2B5EF4-FFF2-40B4-BE49-F238E27FC236}">
                    <a16:creationId xmlns:a16="http://schemas.microsoft.com/office/drawing/2014/main" id="{B95F4086-167E-6DAC-646B-0EC61EF2A9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8463" y="3030538"/>
                <a:ext cx="82550" cy="809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1" name="Oval 155">
                <a:extLst>
                  <a:ext uri="{FF2B5EF4-FFF2-40B4-BE49-F238E27FC236}">
                    <a16:creationId xmlns:a16="http://schemas.microsoft.com/office/drawing/2014/main" id="{BF55E8D3-DD0D-B198-1FBB-DB63DB37BF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8463" y="3030538"/>
                <a:ext cx="82550" cy="809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2" name="Rectangle 156">
                <a:extLst>
                  <a:ext uri="{FF2B5EF4-FFF2-40B4-BE49-F238E27FC236}">
                    <a16:creationId xmlns:a16="http://schemas.microsoft.com/office/drawing/2014/main" id="{F6A6F928-E5C1-238A-ECEE-9E03770423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4688" y="3262313"/>
                <a:ext cx="8576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LS8-</a:t>
                </a:r>
                <a:r>
                  <a:rPr kumimoji="0" lang="en-US" altLang="en-US" sz="14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NSD2</a:t>
                </a:r>
                <a:endParaRPr kumimoji="0" lang="en-US" altLang="en-US" sz="1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3" name="Line 157">
                <a:extLst>
                  <a:ext uri="{FF2B5EF4-FFF2-40B4-BE49-F238E27FC236}">
                    <a16:creationId xmlns:a16="http://schemas.microsoft.com/office/drawing/2014/main" id="{827E3914-DC1B-EF50-FAA2-AFFDD914EC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0201" y="3355975"/>
                <a:ext cx="21748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4" name="Rectangle 158">
                <a:extLst>
                  <a:ext uri="{FF2B5EF4-FFF2-40B4-BE49-F238E27FC236}">
                    <a16:creationId xmlns:a16="http://schemas.microsoft.com/office/drawing/2014/main" id="{3A57C66A-4C64-8C10-9290-BE5CFCFD83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8463" y="3316288"/>
                <a:ext cx="82550" cy="809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5" name="Rectangle 159">
                <a:extLst>
                  <a:ext uri="{FF2B5EF4-FFF2-40B4-BE49-F238E27FC236}">
                    <a16:creationId xmlns:a16="http://schemas.microsoft.com/office/drawing/2014/main" id="{006C6E59-2351-DE7D-0506-2C8D63A97D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8463" y="3316288"/>
                <a:ext cx="82550" cy="809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66" name="Rectangle 160">
                <a:extLst>
                  <a:ext uri="{FF2B5EF4-FFF2-40B4-BE49-F238E27FC236}">
                    <a16:creationId xmlns:a16="http://schemas.microsoft.com/office/drawing/2014/main" id="{D968DAED-E904-1333-8FCB-A8F3A7FFA0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4188" y="5089525"/>
                <a:ext cx="20839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h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7" name="Rectangle 161">
                <a:extLst>
                  <a:ext uri="{FF2B5EF4-FFF2-40B4-BE49-F238E27FC236}">
                    <a16:creationId xmlns:a16="http://schemas.microsoft.com/office/drawing/2014/main" id="{CA449B7E-5329-0488-F116-37333F83D1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275" y="5089525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4h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8" name="Rectangle 162">
                <a:extLst>
                  <a:ext uri="{FF2B5EF4-FFF2-40B4-BE49-F238E27FC236}">
                    <a16:creationId xmlns:a16="http://schemas.microsoft.com/office/drawing/2014/main" id="{C099AE0F-8FCF-98D4-D762-0347B28A2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5313" y="5089525"/>
                <a:ext cx="3077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8h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9" name="Freeform 163">
                <a:extLst>
                  <a:ext uri="{FF2B5EF4-FFF2-40B4-BE49-F238E27FC236}">
                    <a16:creationId xmlns:a16="http://schemas.microsoft.com/office/drawing/2014/main" id="{4C720CB1-2B73-9BD6-61D1-82C15198B5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00426" y="3468688"/>
                <a:ext cx="101600" cy="960438"/>
              </a:xfrm>
              <a:custGeom>
                <a:avLst/>
                <a:gdLst>
                  <a:gd name="T0" fmla="*/ 0 w 64"/>
                  <a:gd name="T1" fmla="*/ 0 h 605"/>
                  <a:gd name="T2" fmla="*/ 64 w 64"/>
                  <a:gd name="T3" fmla="*/ 0 h 605"/>
                  <a:gd name="T4" fmla="*/ 64 w 64"/>
                  <a:gd name="T5" fmla="*/ 605 h 605"/>
                  <a:gd name="T6" fmla="*/ 0 w 64"/>
                  <a:gd name="T7" fmla="*/ 605 h 6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4" h="605">
                    <a:moveTo>
                      <a:pt x="0" y="0"/>
                    </a:moveTo>
                    <a:lnTo>
                      <a:pt x="64" y="0"/>
                    </a:lnTo>
                    <a:lnTo>
                      <a:pt x="64" y="605"/>
                    </a:lnTo>
                    <a:lnTo>
                      <a:pt x="0" y="605"/>
                    </a:lnTo>
                  </a:path>
                </a:pathLst>
              </a:custGeom>
              <a:noFill/>
              <a:ln w="301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70" name="Rectangle 164">
                <a:extLst>
                  <a:ext uri="{FF2B5EF4-FFF2-40B4-BE49-F238E27FC236}">
                    <a16:creationId xmlns:a16="http://schemas.microsoft.com/office/drawing/2014/main" id="{E1E594FD-640F-A6CD-63DA-51DF939FC8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0763" y="3868738"/>
                <a:ext cx="35907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****</a:t>
                </a:r>
                <a:endParaRPr kumimoji="0" lang="en-US" altLang="en-US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1" name="Freeform 165">
                <a:extLst>
                  <a:ext uri="{FF2B5EF4-FFF2-40B4-BE49-F238E27FC236}">
                    <a16:creationId xmlns:a16="http://schemas.microsoft.com/office/drawing/2014/main" id="{0E5969D1-E878-ACAF-0A5E-02A248509D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7463" y="4391025"/>
                <a:ext cx="61913" cy="292100"/>
              </a:xfrm>
              <a:custGeom>
                <a:avLst/>
                <a:gdLst>
                  <a:gd name="T0" fmla="*/ 0 w 39"/>
                  <a:gd name="T1" fmla="*/ 0 h 184"/>
                  <a:gd name="T2" fmla="*/ 39 w 39"/>
                  <a:gd name="T3" fmla="*/ 0 h 184"/>
                  <a:gd name="T4" fmla="*/ 39 w 39"/>
                  <a:gd name="T5" fmla="*/ 184 h 184"/>
                  <a:gd name="T6" fmla="*/ 0 w 39"/>
                  <a:gd name="T7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184">
                    <a:moveTo>
                      <a:pt x="0" y="0"/>
                    </a:moveTo>
                    <a:lnTo>
                      <a:pt x="39" y="0"/>
                    </a:lnTo>
                    <a:lnTo>
                      <a:pt x="39" y="184"/>
                    </a:lnTo>
                    <a:lnTo>
                      <a:pt x="0" y="184"/>
                    </a:lnTo>
                  </a:path>
                </a:pathLst>
              </a:custGeom>
              <a:noFill/>
              <a:ln w="301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/>
              </a:p>
            </p:txBody>
          </p:sp>
          <p:sp>
            <p:nvSpPr>
              <p:cNvPr id="172" name="Rectangle 166">
                <a:extLst>
                  <a:ext uri="{FF2B5EF4-FFF2-40B4-BE49-F238E27FC236}">
                    <a16:creationId xmlns:a16="http://schemas.microsoft.com/office/drawing/2014/main" id="{2A65C8BB-1A57-EDD0-C262-0DEEB98B07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4300" y="4438650"/>
                <a:ext cx="8976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*</a:t>
                </a:r>
                <a:endParaRPr kumimoji="0" lang="en-US" altLang="en-US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3" name="Rectangle 52">
                <a:extLst>
                  <a:ext uri="{FF2B5EF4-FFF2-40B4-BE49-F238E27FC236}">
                    <a16:creationId xmlns:a16="http://schemas.microsoft.com/office/drawing/2014/main" id="{34F1F7F2-7BBB-BB1A-5AFC-6E38C0BE62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-9616" y="3766594"/>
                <a:ext cx="1918795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 defTabSz="914400"/>
                <a:r>
                  <a:rPr kumimoji="0" lang="en-US" altLang="en-US" sz="14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  <a:cs typeface="Times New Roman" panose="02020603050405020304" pitchFamily="18" charset="0"/>
                  </a:rPr>
                  <a:t>Corrected absorbance</a:t>
                </a:r>
              </a:p>
              <a:p>
                <a:pPr lvl="0" algn="ctr" defTabSz="914400"/>
                <a:r>
                  <a:rPr lang="en-US" altLang="en-US" sz="1400" b="1" dirty="0">
                    <a:solidFill>
                      <a:srgbClr val="000000"/>
                    </a:solidFill>
                    <a:latin typeface="Helvetica" pitchFamily="2" charset="0"/>
                    <a:cs typeface="Times New Roman" panose="02020603050405020304" pitchFamily="18" charset="0"/>
                  </a:rPr>
                  <a:t>(OD=620nm)</a:t>
                </a:r>
                <a:endParaRPr kumimoji="0" lang="en-US" altLang="en-US" sz="14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537A47B8-CCE6-48FF-5CAA-133D5AB038AE}"/>
                </a:ext>
              </a:extLst>
            </p:cNvPr>
            <p:cNvSpPr txBox="1"/>
            <p:nvPr/>
          </p:nvSpPr>
          <p:spPr>
            <a:xfrm>
              <a:off x="6102772" y="6618434"/>
              <a:ext cx="2617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  <a:cs typeface="Helvetica"/>
                </a:rPr>
                <a:t>D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DE126597-B64D-6F56-ABB6-D2F517267626}"/>
                </a:ext>
              </a:extLst>
            </p:cNvPr>
            <p:cNvSpPr txBox="1"/>
            <p:nvPr/>
          </p:nvSpPr>
          <p:spPr>
            <a:xfrm>
              <a:off x="1193536" y="6646149"/>
              <a:ext cx="2617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  <a:cs typeface="Helvetica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14340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8B87BA2AB25E442BD3E26FFCCB4725E" ma:contentTypeVersion="14" ma:contentTypeDescription="Create a new document." ma:contentTypeScope="" ma:versionID="49af1c8a26ae5946cd5b396a27bb08e8">
  <xsd:schema xmlns:xsd="http://www.w3.org/2001/XMLSchema" xmlns:xs="http://www.w3.org/2001/XMLSchema" xmlns:p="http://schemas.microsoft.com/office/2006/metadata/properties" xmlns:ns3="1fe4a7e6-0781-4223-92a9-cff86e5a1a8b" xmlns:ns4="379de845-6c3c-40ac-b46f-2ff42365e8a1" targetNamespace="http://schemas.microsoft.com/office/2006/metadata/properties" ma:root="true" ma:fieldsID="e94493a0dda3e71182790e9de226d6ff" ns3:_="" ns4:_="">
    <xsd:import namespace="1fe4a7e6-0781-4223-92a9-cff86e5a1a8b"/>
    <xsd:import namespace="379de845-6c3c-40ac-b46f-2ff42365e8a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4a7e6-0781-4223-92a9-cff86e5a1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9de845-6c3c-40ac-b46f-2ff42365e8a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385C7030-0A6E-45F7-A726-44C3B1FC027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e4a7e6-0781-4223-92a9-cff86e5a1a8b"/>
    <ds:schemaRef ds:uri="379de845-6c3c-40ac-b46f-2ff42365e8a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34C54F3-90B5-41DB-92BF-06E051B9054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D3CA7D9-0DB6-453F-AC5E-4978E32C1A80}">
  <ds:schemaRefs>
    <ds:schemaRef ds:uri="http://schemas.microsoft.com/office/2006/documentManagement/types"/>
    <ds:schemaRef ds:uri="http://schemas.microsoft.com/office/infopath/2007/PartnerControls"/>
    <ds:schemaRef ds:uri="379de845-6c3c-40ac-b46f-2ff42365e8a1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1fe4a7e6-0781-4223-92a9-cff86e5a1a8b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1</TotalTime>
  <Words>108</Words>
  <Application>Microsoft Macintosh PowerPoint</Application>
  <PresentationFormat>Custom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, Dan</dc:creator>
  <cp:lastModifiedBy>Microsoft Office User</cp:lastModifiedBy>
  <cp:revision>9</cp:revision>
  <dcterms:created xsi:type="dcterms:W3CDTF">2022-10-07T18:20:38Z</dcterms:created>
  <dcterms:modified xsi:type="dcterms:W3CDTF">2023-08-22T23:02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B87BA2AB25E442BD3E26FFCCB4725E</vt:lpwstr>
  </property>
</Properties>
</file>